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  <p:sldId id="263" r:id="rId3"/>
    <p:sldId id="262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107" d="100"/>
          <a:sy n="107" d="100"/>
        </p:scale>
        <p:origin x="71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3B7179-8451-4BBC-BCE0-94CD1136092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D90D51A-8A3B-4D66-987C-0A559A58489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C77128F-14E3-4741-BB53-E05B895799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7F2CD2-6C2A-4B5C-80A6-0965F27A4E62}" type="datetimeFigureOut">
              <a:rPr lang="en-US" smtClean="0"/>
              <a:t>6/10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E595D33-9A26-4066-B1E4-8EF33BD8CC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4A47829-3F3B-49FA-BA1D-9FBAF0D6A1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BFA984-7744-48EE-A45A-3854635F25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05724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BAD282-5B3F-455C-9357-D989794059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9959EE5-3E52-48E9-9C95-4055761879F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7D8FD21-DA8D-48E6-97EF-DC44B14786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7F2CD2-6C2A-4B5C-80A6-0965F27A4E62}" type="datetimeFigureOut">
              <a:rPr lang="en-US" smtClean="0"/>
              <a:t>6/10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2DC8E7E-0434-46BC-8F7F-EBABD0105B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BBAEBBE-AE16-4851-A27A-E5F1BD44D5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BFA984-7744-48EE-A45A-3854635F25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29686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8EB2D28-2E11-4D10-B19E-EE87F694641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3BD8B99-3932-44A1-9EE1-5EBAC0715D0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8D0A62F-1E91-4C05-AABF-D95C8973A8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7F2CD2-6C2A-4B5C-80A6-0965F27A4E62}" type="datetimeFigureOut">
              <a:rPr lang="en-US" smtClean="0"/>
              <a:t>6/10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E45492F-3EE3-44C8-8E26-4A87F86200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F1B1A77-54AE-48F7-8C54-0649F05FEF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BFA984-7744-48EE-A45A-3854635F25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67709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E102D4-5F85-43A5-9D12-F6212F6AE96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78C8D20-41B2-452B-AE88-9DF5C23DEDD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5EBFAEA-23BA-49D9-B63C-4431DC9648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7F2CD2-6C2A-4B5C-80A6-0965F27A4E62}" type="datetimeFigureOut">
              <a:rPr lang="en-US" smtClean="0"/>
              <a:t>6/10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62F0440-2185-48C8-BEF5-B69613B8DD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2458CD9-1144-42AB-B650-603E20C2E7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BFA984-7744-48EE-A45A-3854635F25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28316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00B4A3-BD50-4C99-801A-A00404EDEC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C17B00E-2C56-414E-92DC-DE628FA5201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2040442-B581-4FAA-B4EE-60296C6638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7F2CD2-6C2A-4B5C-80A6-0965F27A4E62}" type="datetimeFigureOut">
              <a:rPr lang="en-US" smtClean="0"/>
              <a:t>6/10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8DBBABA-1E42-45DB-B2DE-391170AE00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92306AA-4A06-4E40-BF5C-72CA9757B4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BFA984-7744-48EE-A45A-3854635F25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36121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59E59E-5B77-4EC5-B3D3-D090F45E12A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6282F73-E81D-48C6-A869-370E8D96334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6F67603-7F75-4012-9334-366D241787B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8478402-9E59-467C-8FA9-7E5D57172C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7F2CD2-6C2A-4B5C-80A6-0965F27A4E62}" type="datetimeFigureOut">
              <a:rPr lang="en-US" smtClean="0"/>
              <a:t>6/10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91CC3EC-CE8B-487D-82FA-16BFC82995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848574D-B3EA-443B-B358-DBF136FAF0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BFA984-7744-48EE-A45A-3854635F25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67859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DB8243-1611-41DC-99E8-F992DB26451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8B4A563-C7C8-41B6-BA3F-1FB81100FAE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C3A2124-C9B5-43AC-B092-E24FBEB952E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9F8B29C-D764-45F9-8A29-E9BC1CEA8C4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6F8B25D-1A3F-4AE5-9E6B-AF30FF8B50B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F562587-1F90-444A-8417-C165503C0C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7F2CD2-6C2A-4B5C-80A6-0965F27A4E62}" type="datetimeFigureOut">
              <a:rPr lang="en-US" smtClean="0"/>
              <a:t>6/10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47EB401-8D76-4F48-997A-10C2137603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C01C0E0-1CF5-455B-9E42-026F7A5531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BFA984-7744-48EE-A45A-3854635F25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20236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8F56E0-53CE-46D1-AEBF-FBDB6A9C731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B55112A-2D36-4A99-9B43-AB5FCD8FAE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7F2CD2-6C2A-4B5C-80A6-0965F27A4E62}" type="datetimeFigureOut">
              <a:rPr lang="en-US" smtClean="0"/>
              <a:t>6/10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763049C-41E6-4642-A30D-25679E6002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3C38DA3-F492-4F27-B8D7-845ED71F77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BFA984-7744-48EE-A45A-3854635F25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92914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3BBC9EA-13F4-4FFB-BB92-56945B6BF7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7F2CD2-6C2A-4B5C-80A6-0965F27A4E62}" type="datetimeFigureOut">
              <a:rPr lang="en-US" smtClean="0"/>
              <a:t>6/10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8DB788B-3397-4F73-96B3-675C82E6B9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2A2EBF7-E449-488B-A44C-F58ADE605C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BFA984-7744-48EE-A45A-3854635F25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24622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C551EA-03CB-4B3D-A35F-408AC155F83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E34F0E2-8607-4564-A90C-96F701D9D36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795909B-4FAA-4623-8B4D-CACA9E4A8A6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3C83E5C-77E4-48C9-A41D-F4B2EA8990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7F2CD2-6C2A-4B5C-80A6-0965F27A4E62}" type="datetimeFigureOut">
              <a:rPr lang="en-US" smtClean="0"/>
              <a:t>6/10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C41B2CC-3A73-4FC0-98C3-9319D8A63C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BC848AB-5EA2-4BA4-9EC3-01587529DC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BFA984-7744-48EE-A45A-3854635F25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77612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AA577A-21A6-458B-BF04-7B617D01FD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D34FA80-B4F5-4BC6-A845-313CB94E37A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BFDA12B-90E9-4960-BF6E-896AB8F2286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EF5C390-81EB-4D38-833D-D2F01E1606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7F2CD2-6C2A-4B5C-80A6-0965F27A4E62}" type="datetimeFigureOut">
              <a:rPr lang="en-US" smtClean="0"/>
              <a:t>6/10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68CC5D7-61F2-4A9A-8769-FB811DC486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BFE39C6-AFC4-4DDF-8F66-898D1EC089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BFA984-7744-48EE-A45A-3854635F25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36203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56080D0-6B71-4AF5-A8DC-B2BFCD6C696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23C1D48-29B0-47D9-A8DC-927DBA479FB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95832A9-3014-4F2C-98B2-EC19B8C4B13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7F2CD2-6C2A-4B5C-80A6-0965F27A4E62}" type="datetimeFigureOut">
              <a:rPr lang="en-US" smtClean="0"/>
              <a:t>6/10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07B1154-68EB-44E2-AC96-130996E6626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213CF1E-952C-4D9E-A2AA-961D4C972DF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BFA984-7744-48EE-A45A-3854635F25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72780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364DE8D6-3CFB-4181-AA69-A96098DC2F5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067" t="12379"/>
          <a:stretch/>
        </p:blipFill>
        <p:spPr>
          <a:xfrm rot="5400000">
            <a:off x="8615456" y="2761733"/>
            <a:ext cx="3071445" cy="2174685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A3372F00-8B99-4526-A05F-A32D7A3C330E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04" t="9682" b="4204"/>
          <a:stretch/>
        </p:blipFill>
        <p:spPr>
          <a:xfrm>
            <a:off x="4477475" y="2313348"/>
            <a:ext cx="4544084" cy="3063632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181C4456-C0CD-4738-AF56-69E42E96DBB2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915" t="15498" r="18889" b="9858"/>
          <a:stretch/>
        </p:blipFill>
        <p:spPr>
          <a:xfrm>
            <a:off x="531456" y="2313350"/>
            <a:ext cx="3899876" cy="3066529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95EEF0EE-CF63-41AC-8E53-BFFE06758022}"/>
              </a:ext>
            </a:extLst>
          </p:cNvPr>
          <p:cNvSpPr txBox="1"/>
          <p:nvPr/>
        </p:nvSpPr>
        <p:spPr>
          <a:xfrm>
            <a:off x="2102338" y="5361349"/>
            <a:ext cx="70391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t 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AB4F9410-9829-4632-9BE2-48032FD888FC}"/>
              </a:ext>
            </a:extLst>
          </p:cNvPr>
          <p:cNvSpPr txBox="1"/>
          <p:nvPr/>
        </p:nvSpPr>
        <p:spPr>
          <a:xfrm>
            <a:off x="6537569" y="5349626"/>
            <a:ext cx="70403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t B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048F74DF-C18C-442D-9CE7-83EB6FC087CD}"/>
              </a:ext>
            </a:extLst>
          </p:cNvPr>
          <p:cNvSpPr txBox="1"/>
          <p:nvPr/>
        </p:nvSpPr>
        <p:spPr>
          <a:xfrm>
            <a:off x="9894277" y="5361349"/>
            <a:ext cx="70403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t C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1224192F-0D23-4A7A-A95C-4373751F0664}"/>
              </a:ext>
            </a:extLst>
          </p:cNvPr>
          <p:cNvSpPr txBox="1"/>
          <p:nvPr/>
        </p:nvSpPr>
        <p:spPr>
          <a:xfrm>
            <a:off x="699736" y="784020"/>
            <a:ext cx="10074296" cy="3740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algn="just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b="1" kern="100" dirty="0">
                <a:effectLst/>
                <a:latin typeface="Times New Roman" panose="02020603050405020304" pitchFamily="18" charset="0"/>
                <a:ea typeface="Aptos"/>
                <a:cs typeface="Arial" panose="020B0604020202020204" pitchFamily="34" charset="0"/>
              </a:rPr>
              <a:t>Figure S1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Aptos"/>
                <a:cs typeface="Arial" panose="020B0604020202020204" pitchFamily="34" charset="0"/>
              </a:rPr>
              <a:t>. Photographs of the sampled microbial mats (Mats A, B and C) from the chromium mining site. </a:t>
            </a:r>
            <a:endParaRPr lang="en-US" sz="1800" kern="100" dirty="0">
              <a:effectLst/>
              <a:latin typeface="Aptos"/>
              <a:ea typeface="Aptos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7963150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E3C612A5-FBDE-4A46-82C9-48AA8CB8B927}"/>
              </a:ext>
            </a:extLst>
          </p:cNvPr>
          <p:cNvSpPr txBox="1"/>
          <p:nvPr/>
        </p:nvSpPr>
        <p:spPr>
          <a:xfrm>
            <a:off x="697590" y="275626"/>
            <a:ext cx="1045070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>
                <a:effectLst/>
                <a:latin typeface="Times New Roman" panose="02020603050405020304" pitchFamily="18" charset="0"/>
                <a:ea typeface="Aptos"/>
              </a:rPr>
              <a:t>Figure S2.</a:t>
            </a:r>
            <a:r>
              <a:rPr lang="en-US" sz="1800" dirty="0">
                <a:effectLst/>
                <a:latin typeface="Times New Roman" panose="02020603050405020304" pitchFamily="18" charset="0"/>
                <a:ea typeface="Aptos"/>
              </a:rPr>
              <a:t> The relative abundance (%) of the different detected bacterial phyla/classes (top bar plot) and genera (bottom heatmap) in triplicate samples of the original mats A, B and C. </a:t>
            </a: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7CE881A1-E544-487A-864A-89A1A356632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54012" y="1093695"/>
            <a:ext cx="5318027" cy="541423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2478254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4C2CA2EC-0D12-4BB2-AF68-B6995E10C6D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72921" y="1306885"/>
            <a:ext cx="4686300" cy="37242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755228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40</TotalTime>
  <Words>68</Words>
  <Application>Microsoft Office PowerPoint</Application>
  <PresentationFormat>Widescreen</PresentationFormat>
  <Paragraphs>5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9" baseType="lpstr">
      <vt:lpstr>Aptos</vt:lpstr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HAMMAD TARIQ KHAN</dc:creator>
  <cp:lastModifiedBy>Raeid Abed</cp:lastModifiedBy>
  <cp:revision>36</cp:revision>
  <dcterms:created xsi:type="dcterms:W3CDTF">2025-06-01T05:19:04Z</dcterms:created>
  <dcterms:modified xsi:type="dcterms:W3CDTF">2025-06-10T04:59:33Z</dcterms:modified>
</cp:coreProperties>
</file>